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7" r:id="rId4"/>
    <p:sldId id="258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4" d="100"/>
          <a:sy n="74" d="100"/>
        </p:scale>
        <p:origin x="37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2463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11315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69332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4300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98277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4532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6465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548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457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0187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184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B637A-A5D6-48E5-862B-EB1535E1E7CA}" type="datetimeFigureOut">
              <a:rPr lang="it-IT" smtClean="0"/>
              <a:t>05/05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D23ED0-F855-474C-8011-85FD6D915E7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39720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723900" y="455136"/>
            <a:ext cx="110871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 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|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Q-Q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quantile-quantile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 NDVI results of the GWAS analysis using different methods: 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M (General Linear Model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 (population structure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MLM (Mixed Linear Model) with K (kinship matrix); c) MLM with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 </a:t>
            </a:r>
            <a:r>
              <a:rPr lang="en-US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kinship matrix)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ding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logy-relevant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ci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D-A1, PPD-B1, FT-7A-indel, Rht-B1b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RN-A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covariate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MLM with K (kinship matrix) and Q (population structure) including phenology-relevant loci as covariate.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3278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950" y="95250"/>
            <a:ext cx="5810250" cy="3227917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950" y="3475567"/>
            <a:ext cx="5810250" cy="3227917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6629400" y="4904859"/>
            <a:ext cx="431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MLM-K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6629400" y="1158359"/>
            <a:ext cx="431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GLM-Q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4965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6464300" y="4495800"/>
            <a:ext cx="546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MLM-K + (</a:t>
            </a:r>
            <a:r>
              <a:rPr lang="it-IT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logy-relevant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oci </a:t>
            </a:r>
            <a:r>
              <a:rPr lang="it-IT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variates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6464300" y="1168400"/>
            <a:ext cx="431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MLM-K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magin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8898"/>
            <a:ext cx="5943598" cy="3301999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79801"/>
            <a:ext cx="5943598" cy="3301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1593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6464300" y="4495800"/>
            <a:ext cx="581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) MLM-Q+K + (</a:t>
            </a:r>
            <a:r>
              <a:rPr lang="it-IT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logy-relevant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oci </a:t>
            </a:r>
            <a:r>
              <a:rPr lang="it-IT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variates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>
            <a:off x="6464300" y="1383270"/>
            <a:ext cx="530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) MLM-K + (</a:t>
            </a:r>
            <a:r>
              <a:rPr lang="it-IT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logy-relevant</a:t>
            </a:r>
            <a:r>
              <a:rPr lang="it-IT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i </a:t>
            </a:r>
            <a:r>
              <a:rPr lang="it-IT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variates</a:t>
            </a:r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Immagin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05201"/>
            <a:ext cx="5943598" cy="3301999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1602"/>
            <a:ext cx="5943598" cy="33019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79148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39</Words>
  <Application>Microsoft Office PowerPoint</Application>
  <PresentationFormat>Widescreen</PresentationFormat>
  <Paragraphs>7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Emanuele Condorelli</cp:lastModifiedBy>
  <cp:revision>12</cp:revision>
  <dcterms:created xsi:type="dcterms:W3CDTF">2018-05-02T07:47:29Z</dcterms:created>
  <dcterms:modified xsi:type="dcterms:W3CDTF">2018-05-05T06:00:40Z</dcterms:modified>
</cp:coreProperties>
</file>